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 showGuides="1">
      <p:cViewPr>
        <p:scale>
          <a:sx n="75" d="100"/>
          <a:sy n="75" d="100"/>
        </p:scale>
        <p:origin x="1842" y="2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BBA32-7A55-4632-BE98-062DF75BB773}" type="datetimeFigureOut">
              <a:rPr lang="ko-KR" altLang="en-US" smtClean="0"/>
              <a:t>2026-06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2359A-BF72-49A9-8764-F9CA9DB93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5260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BBA32-7A55-4632-BE98-062DF75BB773}" type="datetimeFigureOut">
              <a:rPr lang="ko-KR" altLang="en-US" smtClean="0"/>
              <a:t>2026-06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2359A-BF72-49A9-8764-F9CA9DB93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05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BBA32-7A55-4632-BE98-062DF75BB773}" type="datetimeFigureOut">
              <a:rPr lang="ko-KR" altLang="en-US" smtClean="0"/>
              <a:t>2026-06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2359A-BF72-49A9-8764-F9CA9DB93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749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BBA32-7A55-4632-BE98-062DF75BB773}" type="datetimeFigureOut">
              <a:rPr lang="ko-KR" altLang="en-US" smtClean="0"/>
              <a:t>2026-06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2359A-BF72-49A9-8764-F9CA9DB93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403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BBA32-7A55-4632-BE98-062DF75BB773}" type="datetimeFigureOut">
              <a:rPr lang="ko-KR" altLang="en-US" smtClean="0"/>
              <a:t>2026-06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2359A-BF72-49A9-8764-F9CA9DB93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32106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BBA32-7A55-4632-BE98-062DF75BB773}" type="datetimeFigureOut">
              <a:rPr lang="ko-KR" altLang="en-US" smtClean="0"/>
              <a:t>2026-06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2359A-BF72-49A9-8764-F9CA9DB93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73641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BBA32-7A55-4632-BE98-062DF75BB773}" type="datetimeFigureOut">
              <a:rPr lang="ko-KR" altLang="en-US" smtClean="0"/>
              <a:t>2026-06-2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2359A-BF72-49A9-8764-F9CA9DB93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82873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BBA32-7A55-4632-BE98-062DF75BB773}" type="datetimeFigureOut">
              <a:rPr lang="ko-KR" altLang="en-US" smtClean="0"/>
              <a:t>2026-06-2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2359A-BF72-49A9-8764-F9CA9DB93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5751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BBA32-7A55-4632-BE98-062DF75BB773}" type="datetimeFigureOut">
              <a:rPr lang="ko-KR" altLang="en-US" smtClean="0"/>
              <a:t>2026-06-2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2359A-BF72-49A9-8764-F9CA9DB93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8579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BBA32-7A55-4632-BE98-062DF75BB773}" type="datetimeFigureOut">
              <a:rPr lang="ko-KR" altLang="en-US" smtClean="0"/>
              <a:t>2026-06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2359A-BF72-49A9-8764-F9CA9DB93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7514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BBA32-7A55-4632-BE98-062DF75BB773}" type="datetimeFigureOut">
              <a:rPr lang="ko-KR" altLang="en-US" smtClean="0"/>
              <a:t>2026-06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2359A-BF72-49A9-8764-F9CA9DB93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40985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C0BBA32-7A55-4632-BE98-062DF75BB773}" type="datetimeFigureOut">
              <a:rPr lang="ko-KR" altLang="en-US" smtClean="0"/>
              <a:t>2026-06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842359A-BF72-49A9-8764-F9CA9DB93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628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 descr="스크린샷, 라인, 텍스트, 그래프이(가) 표시된 사진&#10;&#10;자동 생성된 설명">
            <a:extLst>
              <a:ext uri="{FF2B5EF4-FFF2-40B4-BE49-F238E27FC236}">
                <a16:creationId xmlns:a16="http://schemas.microsoft.com/office/drawing/2014/main" id="{0FEE4FE5-9291-999B-80F0-683D56A186D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60779" y="1884947"/>
            <a:ext cx="5915025" cy="321669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FA6DAB4-90C5-AC98-387D-1B016720E3E8}"/>
              </a:ext>
            </a:extLst>
          </p:cNvPr>
          <p:cNvSpPr txBox="1"/>
          <p:nvPr/>
        </p:nvSpPr>
        <p:spPr>
          <a:xfrm>
            <a:off x="277035" y="380036"/>
            <a:ext cx="628251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verage SNP count per gene across chromosomes in the ZJU1.0 genome. The X-axis represents each chromosome, including the Z chromosome and the Y-axis shows the SNP count per gene. Each blue dot indicates the average SNP density per gene for a given chromosome, with dashed lines highlighting variations.</a:t>
            </a:r>
            <a:endParaRPr lang="ko-KR" altLang="ko-KR" sz="14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93133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9C7E44A1-D931-AE1B-BBAF-C8C2070E62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129" y="1937064"/>
            <a:ext cx="5847742" cy="784828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30BB6C0-F6AF-1CAA-C6D7-688B40DCFD89}"/>
              </a:ext>
            </a:extLst>
          </p:cNvPr>
          <p:cNvSpPr txBox="1"/>
          <p:nvPr/>
        </p:nvSpPr>
        <p:spPr>
          <a:xfrm>
            <a:off x="281392" y="380036"/>
            <a:ext cx="6295215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altLang="ko-KR" sz="1400" b="1" dirty="0">
                <a:latin typeface="Times New Roman"/>
                <a:cs typeface="Times New Roman"/>
              </a:rPr>
              <a:t>Supplementary Figure S2.</a:t>
            </a:r>
            <a:r>
              <a:rPr lang="en-US" altLang="ko-KR" sz="1400" dirty="0">
                <a:latin typeface="Times New Roman"/>
                <a:cs typeface="Times New Roman"/>
              </a:rPr>
              <a:t> SNP-based genetic distance tree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/>
                <a:ea typeface="Times New Roman"/>
                <a:cs typeface="Times New Roman"/>
              </a:rPr>
              <a:t>. The tree was computed using the SNPs applied to the duck panel. The right bar indicates the range of breeds: red for Korean Native Duck, green for Peking Duck, blue for </a:t>
            </a:r>
            <a:r>
              <a:rPr lang="en-US" altLang="ko-KR" sz="1400" dirty="0" err="1">
                <a:solidFill>
                  <a:srgbClr val="000000"/>
                </a:solidFill>
                <a:effectLst/>
                <a:latin typeface="Times New Roman"/>
                <a:ea typeface="Times New Roman"/>
                <a:cs typeface="Times New Roman"/>
              </a:rPr>
              <a:t>Shanma</a:t>
            </a:r>
            <a:r>
              <a:rPr lang="en-US" altLang="ko-KR" sz="1400" dirty="0">
                <a:solidFill>
                  <a:srgbClr val="000000"/>
                </a:solidFill>
                <a:effectLst/>
                <a:latin typeface="Times New Roman"/>
                <a:ea typeface="Times New Roman"/>
                <a:cs typeface="Times New Roman"/>
              </a:rPr>
              <a:t> Duck and orange for Shaoxing Duck. The number on each branch indicates the bootstrap value. The bar </a:t>
            </a:r>
            <a:r>
              <a:rPr lang="en-US" altLang="ko-KR" sz="1400" dirty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rPr>
              <a:t>under the tree is the scale of the branch size.</a:t>
            </a:r>
            <a:endParaRPr lang="en-US" altLang="ko-KR" sz="1400" dirty="0">
              <a:solidFill>
                <a:srgbClr val="000000"/>
              </a:solidFill>
              <a:effectLst/>
              <a:latin typeface="Times New Roman"/>
              <a:ea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5906494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32</Words>
  <Application>Microsoft Office PowerPoint</Application>
  <PresentationFormat>A4 용지(210x297mm)</PresentationFormat>
  <Paragraphs>2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on-Hyong Chung</dc:creator>
  <cp:lastModifiedBy>Won-Hyong Chung</cp:lastModifiedBy>
  <cp:revision>1</cp:revision>
  <dcterms:created xsi:type="dcterms:W3CDTF">2026-06-28T06:48:40Z</dcterms:created>
  <dcterms:modified xsi:type="dcterms:W3CDTF">2026-06-28T06:51:23Z</dcterms:modified>
</cp:coreProperties>
</file>